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96" d="100"/>
          <a:sy n="96" d="100"/>
        </p:scale>
        <p:origin x="101" y="1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814854-2366-42DC-919E-5398AF4296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C223AF4-D0B5-4B06-B1B3-B6CDD3CE96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C13E0F-72A6-4836-9FB6-2CCE71DC57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FB93265-0CA2-489F-B26C-30554C1F9A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EE031FE-F034-404C-98F7-53B1F91E15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69272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D6DD85-7225-4129-A0EA-ABA537AFA1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5742D90-7F90-41AF-9955-7A447CF952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ACBB780-D715-4560-9627-D3916E84DB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42C4DD2-13C1-48F7-8649-D5C896FBDE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EE91BE3-4F20-4EA3-9292-E5F700A07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89843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3A359DA-3821-472C-B808-E26F0C9600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0BC5386-2201-4D23-B99A-895FAA1369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B63896-02C1-471B-84F1-31D084251F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81D391-8AE8-4783-A8EC-0FDADAFF4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9E1AD23-5C77-4CD0-90DA-DB71EFE003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5155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E35EBF0-33F4-4E3D-B65B-21CAFF1FCA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57966FC-FD61-451D-8192-BA34CBD94C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8A9433-6059-42B6-A1AA-7AF49466E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5212271-6B32-47DF-9DB6-CE212152F0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58B159-B0F9-45F9-AABB-03E489A0A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2641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534D14-1529-4444-A80D-FE016B6F27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F7AE081-8C41-4BB2-A798-EC0FC943DE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817311-81CD-49E6-8240-29A3341AC1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446764C-7B56-4967-9EB0-5AFCC41705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EAE704C-EA7C-4D40-B17A-B43F717FD4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80552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FDA63A-35D6-4DD9-AFE7-3FA3203582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0EE4AE5-EDAA-4933-B31C-9A288F278D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1AAB566-7F61-4A6A-96AC-B241034C75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36AA141-FC99-4EA5-9ACF-B58984A483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05728C0-ABD3-4D94-B883-1EA1AD484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4C196A1-6207-453F-83F3-511005191B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7059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CC9C572-9AA9-4524-8516-FD974A2107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4916BD6-7E8B-40B8-80C8-397F4BDFC7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8E92ECB-6BCB-4CFC-A330-3BA1001C2E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CD6CF56-A11C-44E7-842D-DF50661A63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E2CBAC0-80C1-4C8F-B3CA-DA33870DC4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61D00BB-04F6-45AA-821B-E5BFB61A1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65DCB0D-5AC7-4CD2-BC60-F286C3D60C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C3A3EB3-59F3-4082-B038-A93C9CBDA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7115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15D701-5C7A-4C6F-8F69-99E1E6BEAF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43AB703-B586-46E3-A790-D97B400CB6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9887F5F-436F-4CC6-B856-535CD899E5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3B1E434-A5BF-4FBA-8224-1218D32956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108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7DA7A90-EA32-46B6-94D9-22A5AF5DF5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565CF67-E95F-466A-830C-8FDEBF6D4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84814E32-EDE5-474F-9ED5-950392FC2F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6713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DD1F648-EB8A-4E25-A571-BC539C8F3A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839E0C0-7D2A-4A5C-8700-0E1F3D12CE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95956C8-DC56-4727-A7EA-5E70463E2B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19F76A0-51CD-47E2-8B85-FB20A67AAB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E89DE49-6901-43FC-B801-A4A217BD68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A615B1A-E94A-43F4-AFF2-EE6245B418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2304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FD1BB2A-CD43-4742-9D71-FA62BA3FD3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FD806BB-0AAE-4032-8530-4E31516207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6F8DE99-9E0F-4492-B23B-23EFD9D3B6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04C05EE-40C4-479A-98C9-DFB38DF5AC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D6F9542-8116-4DEB-964C-8A93F456F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D9141C4-C488-4998-8350-6DDE9F5F47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1417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1DE41ED-680D-4531-88EF-B0693126BB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B21DB1F-AE5E-47B4-B9FE-58D56987B4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CD346E6-3A47-4C4E-BDFC-6723CFD340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57F42A-F7DD-436D-B91C-6ECC43E55D5A}" type="datetimeFigureOut">
              <a:rPr kumimoji="1" lang="ja-JP" altLang="en-US" smtClean="0"/>
              <a:t>2025/12/5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9C40DB9-29F5-4560-A2C3-88CDDCB926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0BE74E0-0162-42C4-B72F-B4ADDFB7EF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E5E0B8-919E-4077-8564-19FF99A63E8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2181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3006BF40-4267-4C17-9259-DD22CDE94A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8825" y="1028700"/>
            <a:ext cx="8134350" cy="4800600"/>
          </a:xfrm>
          <a:prstGeom prst="rect">
            <a:avLst/>
          </a:prstGeom>
        </p:spPr>
      </p:pic>
      <p:sp>
        <p:nvSpPr>
          <p:cNvPr id="3" name="Rectangle 97">
            <a:extLst>
              <a:ext uri="{FF2B5EF4-FFF2-40B4-BE49-F238E27FC236}">
                <a16:creationId xmlns:a16="http://schemas.microsoft.com/office/drawing/2014/main" id="{8945C69C-64C1-4571-8DFE-1E154C697E5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65015" y="2926607"/>
            <a:ext cx="104939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en-US" altLang="ja-JP" sz="1800" b="1" dirty="0">
                <a:solidFill>
                  <a:srgbClr val="000000"/>
                </a:solidFill>
                <a:latin typeface="Arial" panose="020B0604020202020204" pitchFamily="34" charset="0"/>
                <a:ea typeface="MS UI Gothic"/>
                <a:cs typeface="Arial" panose="020B0604020202020204" pitchFamily="34" charset="0"/>
              </a:rPr>
              <a:t> </a:t>
            </a:r>
            <a:r>
              <a:rPr lang="en-US" altLang="ja-JP" sz="1800" b="1" i="1" dirty="0">
                <a:solidFill>
                  <a:srgbClr val="000000"/>
                </a:solidFill>
                <a:latin typeface="Arial" panose="020B0604020202020204" pitchFamily="34" charset="0"/>
                <a:ea typeface="MS UI Gothic"/>
                <a:cs typeface="Arial" panose="020B0604020202020204" pitchFamily="34" charset="0"/>
              </a:rPr>
              <a:t>P </a:t>
            </a:r>
            <a:r>
              <a:rPr lang="en-US" altLang="ja-JP" sz="1800" b="1" dirty="0">
                <a:solidFill>
                  <a:srgbClr val="000000"/>
                </a:solidFill>
                <a:latin typeface="Arial" panose="020B0604020202020204" pitchFamily="34" charset="0"/>
                <a:ea typeface="MS UI Gothic"/>
                <a:cs typeface="Arial" panose="020B0604020202020204" pitchFamily="34" charset="0"/>
              </a:rPr>
              <a:t>= 0.175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FCB73EB-57E7-41D4-82FB-55A3EF1386D8}"/>
              </a:ext>
            </a:extLst>
          </p:cNvPr>
          <p:cNvSpPr txBox="1"/>
          <p:nvPr/>
        </p:nvSpPr>
        <p:spPr>
          <a:xfrm>
            <a:off x="1371602" y="5393487"/>
            <a:ext cx="18478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AB71178-B2AA-49F3-AA5F-D0C77F14E718}"/>
              </a:ext>
            </a:extLst>
          </p:cNvPr>
          <p:cNvSpPr txBox="1"/>
          <p:nvPr/>
        </p:nvSpPr>
        <p:spPr>
          <a:xfrm>
            <a:off x="1371602" y="5810338"/>
            <a:ext cx="68987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GPS:0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or 1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4              4            4        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 1        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3E20A2D-2E44-46E4-B520-789AB8271814}"/>
              </a:ext>
            </a:extLst>
          </p:cNvPr>
          <p:cNvSpPr txBox="1"/>
          <p:nvPr/>
        </p:nvSpPr>
        <p:spPr>
          <a:xfrm>
            <a:off x="1725707" y="6110655"/>
            <a:ext cx="68987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GPS: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4       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 1             0        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        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107D7D01-79D3-41C5-94C9-40927D80D8B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66863" y="2036358"/>
            <a:ext cx="573074" cy="377985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5976BBA-C489-4D3E-BA5F-ABDDF52F35B9}"/>
              </a:ext>
            </a:extLst>
          </p:cNvPr>
          <p:cNvSpPr txBox="1"/>
          <p:nvPr/>
        </p:nvSpPr>
        <p:spPr>
          <a:xfrm>
            <a:off x="0" y="0"/>
            <a:ext cx="12192000" cy="11151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8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2.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Overall survival in patients with unresectable or metastatic biliary tract cancer receiving gemcitabine plus cisplatin plus durvalumab based on the modified Glasgow Prognostic Score (</a:t>
            </a:r>
            <a:r>
              <a:rPr lang="en-US" altLang="ja-JP" sz="18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GPS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; 0–1 vs. 2).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97884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67</Words>
  <Application>Microsoft Office PowerPoint</Application>
  <PresentationFormat>ワイド画面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福司弥生</dc:creator>
  <cp:lastModifiedBy>KAZUMA FUJITA</cp:lastModifiedBy>
  <cp:revision>15</cp:revision>
  <dcterms:created xsi:type="dcterms:W3CDTF">2024-07-04T09:22:40Z</dcterms:created>
  <dcterms:modified xsi:type="dcterms:W3CDTF">2025-12-05T04:36:25Z</dcterms:modified>
</cp:coreProperties>
</file>